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72" d="100"/>
          <a:sy n="72" d="100"/>
        </p:scale>
        <p:origin x="-84" y="-25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D291DB-D928-4826-8D29-D6A1FE221E9C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656B3D5-D02F-4930-A5F9-CADDF112C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19614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656B3D5-D02F-4930-A5F9-CADDF112C8E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88191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289BE-1BBC-C44C-879C-9EE81D072FC5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6D8B6-9FBB-4E4D-B743-D03E53A6A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853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289BE-1BBC-C44C-879C-9EE81D072FC5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6D8B6-9FBB-4E4D-B743-D03E53A6A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62978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289BE-1BBC-C44C-879C-9EE81D072FC5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6D8B6-9FBB-4E4D-B743-D03E53A6A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0585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289BE-1BBC-C44C-879C-9EE81D072FC5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6D8B6-9FBB-4E4D-B743-D03E53A6A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2908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289BE-1BBC-C44C-879C-9EE81D072FC5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6D8B6-9FBB-4E4D-B743-D03E53A6A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06133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289BE-1BBC-C44C-879C-9EE81D072FC5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6D8B6-9FBB-4E4D-B743-D03E53A6A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4730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289BE-1BBC-C44C-879C-9EE81D072FC5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6D8B6-9FBB-4E4D-B743-D03E53A6A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134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289BE-1BBC-C44C-879C-9EE81D072FC5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6D8B6-9FBB-4E4D-B743-D03E53A6A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3606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289BE-1BBC-C44C-879C-9EE81D072FC5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6D8B6-9FBB-4E4D-B743-D03E53A6A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58057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289BE-1BBC-C44C-879C-9EE81D072FC5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6D8B6-9FBB-4E4D-B743-D03E53A6A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39869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289BE-1BBC-C44C-879C-9EE81D072FC5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26D8B6-9FBB-4E4D-B743-D03E53A6A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43668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2289BE-1BBC-C44C-879C-9EE81D072FC5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26D8B6-9FBB-4E4D-B743-D03E53A6A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636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98913608"/>
              </p:ext>
            </p:extLst>
          </p:nvPr>
        </p:nvGraphicFramePr>
        <p:xfrm>
          <a:off x="113157" y="510676"/>
          <a:ext cx="8889385" cy="6347324"/>
        </p:xfrm>
        <a:graphic>
          <a:graphicData uri="http://schemas.openxmlformats.org/drawingml/2006/table">
            <a:tbl>
              <a:tblPr/>
              <a:tblGrid>
                <a:gridCol w="666386"/>
                <a:gridCol w="414204"/>
                <a:gridCol w="805346"/>
                <a:gridCol w="540295"/>
                <a:gridCol w="540295"/>
                <a:gridCol w="652431"/>
                <a:gridCol w="632044"/>
                <a:gridCol w="540295"/>
                <a:gridCol w="540295"/>
                <a:gridCol w="713598"/>
                <a:gridCol w="540295"/>
                <a:gridCol w="825735"/>
                <a:gridCol w="723792"/>
                <a:gridCol w="754374"/>
              </a:tblGrid>
              <a:tr h="454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uthor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ar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rief Name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h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terial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rocedur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ho Provided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ow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here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hen and How Much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ailoring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odification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lanned Fidelity Assessment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ctual Fidelity Assessment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</a:tr>
              <a:tr h="153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ustin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3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46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issonnett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3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8472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ojadzievski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2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3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ritto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4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15105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llinsworth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4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3964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mı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́n-Colet 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4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153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rabtree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4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3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ramm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4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153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ramm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4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3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ramm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2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153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ickinson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4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3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ickinson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4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153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arle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4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3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oldwater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4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153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alladay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4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3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arihara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4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153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einel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5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3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olm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4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153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oltrop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5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3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Ku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5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153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Ku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4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3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angwel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4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153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cke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2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3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rtin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6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153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ssoud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5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3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cGough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6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153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el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4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3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chma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3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17276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hilis-Tsimika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4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3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illero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4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153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oland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2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3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ack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2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153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hauer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3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3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midth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3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153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midth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3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3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u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3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15374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Van Durme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15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rtially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7146" marR="7146" marT="7146" marB="0" anchor="b">
                    <a:lnL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46873" y="0"/>
            <a:ext cx="870243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S3 Table. </a:t>
            </a:r>
            <a:r>
              <a:rPr lang="en-US" sz="1600" b="1" dirty="0"/>
              <a:t>Methods reporting and bias </a:t>
            </a:r>
            <a:r>
              <a:rPr lang="en-US" sz="1600" b="1" dirty="0" smtClean="0"/>
              <a:t>protection based on </a:t>
            </a:r>
            <a:r>
              <a:rPr lang="en-US" sz="1600" b="1" dirty="0" err="1" smtClean="0"/>
              <a:t>TIDieR</a:t>
            </a:r>
            <a:r>
              <a:rPr lang="en-US" sz="1600" b="1" dirty="0" smtClean="0"/>
              <a:t> Checklist Criteria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4631192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557</Words>
  <Application>Microsoft Office PowerPoint</Application>
  <PresentationFormat>On-screen Show (4:3)</PresentationFormat>
  <Paragraphs>53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sey Boehmer</dc:creator>
  <cp:lastModifiedBy>Kasey R Boehmer</cp:lastModifiedBy>
  <cp:revision>8</cp:revision>
  <dcterms:created xsi:type="dcterms:W3CDTF">2017-01-26T00:50:52Z</dcterms:created>
  <dcterms:modified xsi:type="dcterms:W3CDTF">2018-01-31T19:53:57Z</dcterms:modified>
</cp:coreProperties>
</file>